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056" y="-7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E51D57-3E5B-4EB6-89BE-FA3C9853DBB1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78FA32-0EF5-4990-AD85-25CF79BE4594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426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78FA32-0EF5-4990-AD85-25CF79BE4594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54EFD-9BE1-4DA4-9C7D-AC0538C33EB5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280A7-2C79-485D-AD13-E7D85559B8A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2123728" y="3861048"/>
            <a:ext cx="5328592" cy="1296144"/>
          </a:xfrm>
        </p:spPr>
        <p:txBody>
          <a:bodyPr>
            <a:normAutofit/>
          </a:bodyPr>
          <a:lstStyle/>
          <a:p>
            <a:pPr algn="just"/>
            <a:r>
              <a:rPr lang="fr-FR" sz="1100" b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fr-FR" sz="1100" b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3. </a:t>
            </a:r>
            <a:r>
              <a:rPr lang="fr-FR" sz="11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xpression of spiralin in </a:t>
            </a:r>
            <a:r>
              <a:rPr lang="fr-FR" sz="11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cc</a:t>
            </a:r>
            <a:r>
              <a:rPr lang="fr-FR" sz="11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using</a:t>
            </a:r>
            <a:r>
              <a:rPr lang="fr-FR" sz="11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pMyBK1 </a:t>
            </a:r>
            <a:r>
              <a:rPr lang="fr-FR" sz="11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derivatives</a:t>
            </a:r>
            <a:r>
              <a:rPr lang="fr-FR" sz="11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</a:p>
          <a:p>
            <a:pPr algn="just"/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hole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ell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dot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mmunoblot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of 12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cc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transformants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arboring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the spiralin expression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ector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pCM-K3-spi (a) or the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mpty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ector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pCM-K3 (b). Mycoplasma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ells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ere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pplied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to a nitrocellulose membrane and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robed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ith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abbit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anti-spiralin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ntibodies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and anti-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abbit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gG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roxidase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njugate</a:t>
            </a:r>
            <a:r>
              <a:rPr lang="fr-FR" sz="11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  <a:endParaRPr lang="fr-FR" sz="11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Groupe 14"/>
          <p:cNvGrpSpPr/>
          <p:nvPr/>
        </p:nvGrpSpPr>
        <p:grpSpPr>
          <a:xfrm>
            <a:off x="3029991" y="2036137"/>
            <a:ext cx="2982169" cy="1608887"/>
            <a:chOff x="3029991" y="2036137"/>
            <a:chExt cx="2982169" cy="1608887"/>
          </a:xfrm>
        </p:grpSpPr>
        <p:pic>
          <p:nvPicPr>
            <p:cNvPr id="5" name="Image 4" descr="img160-3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519963" y="2036137"/>
              <a:ext cx="2492197" cy="1608887"/>
            </a:xfrm>
            <a:prstGeom prst="rect">
              <a:avLst/>
            </a:prstGeom>
          </p:spPr>
        </p:pic>
        <p:sp>
          <p:nvSpPr>
            <p:cNvPr id="9" name="ZoneTexte 8"/>
            <p:cNvSpPr txBox="1"/>
            <p:nvPr/>
          </p:nvSpPr>
          <p:spPr>
            <a:xfrm>
              <a:off x="3029991" y="2343137"/>
              <a:ext cx="2712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 smtClean="0"/>
                <a:t>a</a:t>
              </a:r>
              <a:endParaRPr lang="fr-FR" sz="1400" dirty="0"/>
            </a:p>
          </p:txBody>
        </p:sp>
        <p:sp>
          <p:nvSpPr>
            <p:cNvPr id="11" name="Accolade ouvrante 10"/>
            <p:cNvSpPr/>
            <p:nvPr/>
          </p:nvSpPr>
          <p:spPr>
            <a:xfrm>
              <a:off x="3385554" y="2170546"/>
              <a:ext cx="72008" cy="648072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Accolade ouvrante 11"/>
            <p:cNvSpPr/>
            <p:nvPr/>
          </p:nvSpPr>
          <p:spPr>
            <a:xfrm>
              <a:off x="3385554" y="2890626"/>
              <a:ext cx="72008" cy="648072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3103993" y="3039343"/>
              <a:ext cx="2792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400" dirty="0" smtClean="0"/>
                <a:t>b</a:t>
              </a:r>
              <a:endParaRPr lang="fr-FR" sz="14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</TotalTime>
  <Words>60</Words>
  <Application>Microsoft Office PowerPoint</Application>
  <PresentationFormat>Affichage à l'écran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demol38</dc:creator>
  <cp:lastModifiedBy>AB</cp:lastModifiedBy>
  <cp:revision>31</cp:revision>
  <cp:lastPrinted>2012-08-08T09:36:10Z</cp:lastPrinted>
  <dcterms:created xsi:type="dcterms:W3CDTF">2012-02-15T09:38:30Z</dcterms:created>
  <dcterms:modified xsi:type="dcterms:W3CDTF">2012-10-26T13:57:00Z</dcterms:modified>
</cp:coreProperties>
</file>